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232174-271D-4940-8B11-9A06CEA91A1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FF2AF8-4A9E-4A7F-A54F-AF5DF4BEBB5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34AADE-050F-46D2-A05C-A77CB49BBBE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B0BF54-51FC-4DFA-BC9D-CA0B65F869E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63BCB7-952D-43D9-8176-6E0776ACDF2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C199F2-01BC-4B8E-BA2C-44966E1FB67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B4F0E9-32E0-46B3-842A-A2E19CC2351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26E26A-17CC-4708-95E4-8469146B550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9EC02E-4A3A-4D20-A46B-F5E4CAEBCDE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9B224C-3690-4048-9AB6-2F901B76AED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0FCB83-154B-4654-B8B6-0AED68775A7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DF538E-21ED-42D7-86C9-5E06877AE5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3C57CA3-E2E0-4087-BCB8-3D6A07106ADE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图片 3" descr="Fig.S1.tif"/>
          <p:cNvPicPr/>
          <p:nvPr/>
        </p:nvPicPr>
        <p:blipFill>
          <a:blip r:embed="rId1"/>
          <a:stretch/>
        </p:blipFill>
        <p:spPr>
          <a:xfrm>
            <a:off x="74520" y="785880"/>
            <a:ext cx="8994960" cy="5857920"/>
          </a:xfrm>
          <a:prstGeom prst="rect">
            <a:avLst/>
          </a:prstGeom>
          <a:ln w="0">
            <a:noFill/>
          </a:ln>
        </p:spPr>
      </p:pic>
      <p:sp>
        <p:nvSpPr>
          <p:cNvPr id="42" name="Rectangle 1"/>
          <p:cNvSpPr/>
          <p:nvPr/>
        </p:nvSpPr>
        <p:spPr>
          <a:xfrm>
            <a:off x="0" y="49680"/>
            <a:ext cx="914400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catter plots of evolutionary rate of annuals against that of perennials for both nuclear and chloroplast genes estimated by the outgroup-dependent method. Cases in all 4 annual-perennial cross-comparison are shown. The dash line is the diagonal line with a slope equals to 1, and the red line is the regression lin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内容占位符 3" descr="Fig.S2.tif"/>
          <p:cNvPicPr/>
          <p:nvPr/>
        </p:nvPicPr>
        <p:blipFill>
          <a:blip r:embed="rId1"/>
          <a:stretch/>
        </p:blipFill>
        <p:spPr>
          <a:xfrm>
            <a:off x="214200" y="785880"/>
            <a:ext cx="8602920" cy="5786280"/>
          </a:xfrm>
          <a:prstGeom prst="rect">
            <a:avLst/>
          </a:prstGeom>
          <a:ln w="0">
            <a:noFill/>
          </a:ln>
        </p:spPr>
      </p:pic>
      <p:sp>
        <p:nvSpPr>
          <p:cNvPr id="44" name="Rectangle 1"/>
          <p:cNvSpPr/>
          <p:nvPr/>
        </p:nvSpPr>
        <p:spPr>
          <a:xfrm>
            <a:off x="0" y="2160"/>
            <a:ext cx="914400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2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Scatter plots of evolutionary rates of annuals against that of perennials for all 3 sub-datasets of non-housekeeping gene families estimated by the outgroup-dependent method. Cases in all 4 annual-perennial cross-comparison are shown. The dash line is the diagonal line with a slope equals to 1, and the red line is the regression lin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内容占位符 3" descr="Fig.S3.tif"/>
          <p:cNvPicPr/>
          <p:nvPr/>
        </p:nvPicPr>
        <p:blipFill>
          <a:blip r:embed="rId1"/>
          <a:stretch/>
        </p:blipFill>
        <p:spPr>
          <a:xfrm>
            <a:off x="150840" y="785880"/>
            <a:ext cx="8842320" cy="5929200"/>
          </a:xfrm>
          <a:prstGeom prst="rect">
            <a:avLst/>
          </a:prstGeom>
          <a:ln w="0">
            <a:noFill/>
          </a:ln>
        </p:spPr>
      </p:pic>
      <p:sp>
        <p:nvSpPr>
          <p:cNvPr id="46" name="Rectangle 1"/>
          <p:cNvSpPr/>
          <p:nvPr/>
        </p:nvSpPr>
        <p:spPr>
          <a:xfrm>
            <a:off x="0" y="2160"/>
            <a:ext cx="914400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3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catter plots of evolutionary rate in annuals against that in perennials for the 3 sub-datasets collected from non-housekeeping gene families estimated by the ML method. Cases in all 4 annual-perennial cross-comparisons are shown. The dash line is the diagonal line with a slope equals to 1, and the red line is the regression lin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YJX</cp:lastModifiedBy>
  <dcterms:modified xsi:type="dcterms:W3CDTF">2010-05-29T14:42:57Z</dcterms:modified>
  <cp:revision>4</cp:revision>
  <dc:subject/>
  <dc:title>幻灯片 1</dc:title>
</cp:coreProperties>
</file>